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1463"/>
    <p:restoredTop sz="95748"/>
  </p:normalViewPr>
  <p:slideViewPr>
    <p:cSldViewPr snapToGrid="0" snapToObjects="1">
      <p:cViewPr varScale="1">
        <p:scale>
          <a:sx n="110" d="100"/>
          <a:sy n="110" d="100"/>
        </p:scale>
        <p:origin x="296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1CE2CF-0D31-204D-8B60-D7AB52DF554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31B032E-5B42-A94A-8745-6B486676F77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1468C58-58DF-F842-82DA-A39BF1C49C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E9D59-DF83-054E-8853-4AC735B1D55C}" type="datetimeFigureOut">
              <a:rPr lang="en-US" smtClean="0"/>
              <a:t>11/1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2B674EE-3FBB-6649-B987-998A312F66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AFE5D8-C67C-3546-AF8E-1A006EBE5A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E36E6-6DB2-3047-B6D8-7D271E9012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07381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8C460C-5760-9445-B00F-403175A62C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226406C-3292-5D47-9327-15378036754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A26561-FCF5-4E48-9FFA-2F98D8AF31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E9D59-DF83-054E-8853-4AC735B1D55C}" type="datetimeFigureOut">
              <a:rPr lang="en-US" smtClean="0"/>
              <a:t>11/1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441912-E731-0040-83A9-A60F202492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E3CE9F-94BB-AA47-ACF0-D34B8D6EF5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E36E6-6DB2-3047-B6D8-7D271E9012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75018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E580508-B8BF-7B48-9A51-D361CB1D9A5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1263D40-159C-1041-ACFA-C4FB3416F15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124CEF-EAFD-294A-BAE6-78947DD2F7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E9D59-DF83-054E-8853-4AC735B1D55C}" type="datetimeFigureOut">
              <a:rPr lang="en-US" smtClean="0"/>
              <a:t>11/1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85104D-110F-4449-8C39-243EF53372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70C6E6-C238-9C42-B6F8-50C55639F7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E36E6-6DB2-3047-B6D8-7D271E9012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2007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7F435D-7A29-9E49-B21A-660FF8FCFA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16906DF-0A32-9243-82ED-5078F38FB74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24F10C-8BF4-6241-9E44-935B6FCECD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E9D59-DF83-054E-8853-4AC735B1D55C}" type="datetimeFigureOut">
              <a:rPr lang="en-US" smtClean="0"/>
              <a:t>11/1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F25DD8-0C21-564B-971E-754FF80E92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7FEC10-687D-194F-8314-BE79414232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E36E6-6DB2-3047-B6D8-7D271E9012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37243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F11147-5A28-2A47-B7DD-9797C17065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64A813C-B435-2341-96A3-FD94FB66D0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75D296-F0E6-A047-8B44-6C9DDCFD11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E9D59-DF83-054E-8853-4AC735B1D55C}" type="datetimeFigureOut">
              <a:rPr lang="en-US" smtClean="0"/>
              <a:t>11/1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175A4A-1CBF-0742-9E54-5996A13106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4C0919-771B-DB44-A445-72683A3B09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E36E6-6DB2-3047-B6D8-7D271E9012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5165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5B1634-4785-7641-B986-73D9DDEF2F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8AF5A0D-1B3D-A34D-BF31-BD362207DDA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B7FA89B-66F7-C148-9C1E-AEA9D635EE9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F70DD0E-467A-3E4E-8EBE-6E10035268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E9D59-DF83-054E-8853-4AC735B1D55C}" type="datetimeFigureOut">
              <a:rPr lang="en-US" smtClean="0"/>
              <a:t>11/18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C44B4FE-079D-9344-8504-BB93AE2983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538191B-F13D-E641-A68D-CB66219010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E36E6-6DB2-3047-B6D8-7D271E9012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82942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9F5293-883D-E44E-8D62-193F8C968E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CD7EFB3-21FC-9444-A5E5-F36CCB35D7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745E825-507B-1F45-80FC-43F30E308A1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76CFF54-DDE7-0048-9AA3-468D5A14058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C5ED7E4-ED4F-4F43-AF12-E9BFF5454E1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510D02D-F263-814B-8ACC-649C0B6E3C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E9D59-DF83-054E-8853-4AC735B1D55C}" type="datetimeFigureOut">
              <a:rPr lang="en-US" smtClean="0"/>
              <a:t>11/18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7C2ED81-C35E-9E4B-AED7-D305B162D9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133D951-557D-E247-AC8E-498EFC1978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E36E6-6DB2-3047-B6D8-7D271E9012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44618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433A3E-7F9E-3848-BA0D-2885686A14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CD62CC8-B2DB-BE4E-96BC-655AFC99C9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E9D59-DF83-054E-8853-4AC735B1D55C}" type="datetimeFigureOut">
              <a:rPr lang="en-US" smtClean="0"/>
              <a:t>11/18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34D7597-249B-9B41-9D3A-D0B917ED04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557578D-756C-BC4F-B71B-17F3196412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E36E6-6DB2-3047-B6D8-7D271E9012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36385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838E0E2-8279-6346-92AF-EADF15D0BE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E9D59-DF83-054E-8853-4AC735B1D55C}" type="datetimeFigureOut">
              <a:rPr lang="en-US" smtClean="0"/>
              <a:t>11/18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7CFF68C-F039-894C-8FED-B52DE8A96D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57F1ED3-F0D3-F048-81ED-5F9E8E4C0A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E36E6-6DB2-3047-B6D8-7D271E9012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49487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66A241-468F-4745-9C84-12DE7B1574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2BC3D88-2C19-B34E-B6C8-D768A6CC02F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CC5B917-6ADD-F640-A872-EECFB95EC9C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A0923D8-EB8C-E643-B667-3E1D1E7BCC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E9D59-DF83-054E-8853-4AC735B1D55C}" type="datetimeFigureOut">
              <a:rPr lang="en-US" smtClean="0"/>
              <a:t>11/18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33A846E-2458-2D47-9331-37F54D0B41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1E96DFA-840C-364F-987F-FCF592D0AE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E36E6-6DB2-3047-B6D8-7D271E9012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62009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5A0C30-698D-5743-A0FE-F29DCB95F2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D2224E2-304B-2540-B104-57D78827744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F7B03A5-AB2D-694B-A414-A2FCC524E60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0A40D69-201B-7A43-A61F-DE6FBA3129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E9D59-DF83-054E-8853-4AC735B1D55C}" type="datetimeFigureOut">
              <a:rPr lang="en-US" smtClean="0"/>
              <a:t>11/18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F9D8F4A-3253-3C42-B437-AFE0D69CD6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4F9ED31-47D5-374D-AA3F-A074AE94CF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E36E6-6DB2-3047-B6D8-7D271E9012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5525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C80DDC6-E2AD-F34B-9E92-7B8578DCCF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AD38188-AB8B-5245-85E7-FDE50B950C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63ABA7-B6AE-954C-A43B-3634017982A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0E9D59-DF83-054E-8853-4AC735B1D55C}" type="datetimeFigureOut">
              <a:rPr lang="en-US" smtClean="0"/>
              <a:t>11/1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A892E5-00B4-454D-9968-A9F70191F22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EC7C2E-ACAE-F94E-87BB-8DBF1E7BF5C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1E36E6-6DB2-3047-B6D8-7D271E9012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52820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D3D3A1-EFFB-9B4B-A77D-D2E92D264F14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en-US" sz="3600" b="1" dirty="0"/>
              <a:t>iMyoblasts for ex vivo and in vivo investigations of human myogenesis and disease modeling</a:t>
            </a:r>
            <a:r>
              <a:rPr lang="en-US" sz="3600" dirty="0">
                <a:effectLst/>
              </a:rPr>
              <a:t> </a:t>
            </a:r>
            <a:endParaRPr lang="en-US" sz="3600" dirty="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611922F-057B-7F48-A3F2-E390F523666D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/>
              <a:t>Source data for </a:t>
            </a:r>
            <a:r>
              <a:rPr lang="en-US"/>
              <a:t>Figure 9F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663669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380028-014B-4442-964F-C002008DA3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ource data for Figure 9F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ED45B0E5-84D0-9B47-A7AB-3BCA13A8202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09658" y="2064730"/>
            <a:ext cx="5008771" cy="376133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CDAF4FFE-8DDD-3742-93A3-3D5E6691B732}"/>
              </a:ext>
            </a:extLst>
          </p:cNvPr>
          <p:cNvSpPr txBox="1"/>
          <p:nvPr/>
        </p:nvSpPr>
        <p:spPr>
          <a:xfrm>
            <a:off x="7260255" y="3059668"/>
            <a:ext cx="16173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α</a:t>
            </a:r>
            <a:r>
              <a:rPr lang="en-US" dirty="0"/>
              <a:t>-</a:t>
            </a:r>
            <a:r>
              <a:rPr lang="en-US" dirty="0" err="1"/>
              <a:t>dystroglycan</a:t>
            </a:r>
            <a:endParaRPr 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2E57924-0AE0-A940-8B85-8EE221EA84CA}"/>
              </a:ext>
            </a:extLst>
          </p:cNvPr>
          <p:cNvSpPr txBox="1"/>
          <p:nvPr/>
        </p:nvSpPr>
        <p:spPr>
          <a:xfrm>
            <a:off x="7268270" y="4797980"/>
            <a:ext cx="16092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β</a:t>
            </a:r>
            <a:r>
              <a:rPr lang="en-US" dirty="0"/>
              <a:t>-</a:t>
            </a:r>
            <a:r>
              <a:rPr lang="en-US" dirty="0" err="1"/>
              <a:t>dystroglycan</a:t>
            </a:r>
            <a:endParaRPr 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7BE76F7-81A9-0740-9EED-BC712368373B}"/>
              </a:ext>
            </a:extLst>
          </p:cNvPr>
          <p:cNvSpPr txBox="1"/>
          <p:nvPr/>
        </p:nvSpPr>
        <p:spPr>
          <a:xfrm>
            <a:off x="838200" y="1367522"/>
            <a:ext cx="85606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Membrane was cut and probed with </a:t>
            </a:r>
            <a:r>
              <a:rPr lang="el-GR" dirty="0"/>
              <a:t>α</a:t>
            </a:r>
            <a:r>
              <a:rPr lang="en-US" dirty="0"/>
              <a:t>-dystroglycan (IIH6) and </a:t>
            </a:r>
            <a:r>
              <a:rPr lang="el-GR" dirty="0"/>
              <a:t>β</a:t>
            </a:r>
            <a:r>
              <a:rPr lang="en-US" dirty="0"/>
              <a:t>-dystroglycan antibodies </a:t>
            </a:r>
          </a:p>
        </p:txBody>
      </p:sp>
    </p:spTree>
    <p:extLst>
      <p:ext uri="{BB962C8B-B14F-4D97-AF65-F5344CB8AC3E}">
        <p14:creationId xmlns:p14="http://schemas.microsoft.com/office/powerpoint/2010/main" val="14116881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59E085-F63A-774B-A46F-5D1AA56F7F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ource data for Figure 9F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3CB501FA-2D0B-5245-ACA3-BDEE3F2CAE2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326025" y="2306301"/>
            <a:ext cx="2187705" cy="349603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821E9D5C-3AD4-3F43-8FAC-6938A9F92219}"/>
              </a:ext>
            </a:extLst>
          </p:cNvPr>
          <p:cNvSpPr txBox="1"/>
          <p:nvPr/>
        </p:nvSpPr>
        <p:spPr>
          <a:xfrm>
            <a:off x="6629635" y="2992085"/>
            <a:ext cx="16173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α</a:t>
            </a:r>
            <a:r>
              <a:rPr lang="en-US" dirty="0"/>
              <a:t>-</a:t>
            </a:r>
            <a:r>
              <a:rPr lang="en-US" dirty="0" err="1"/>
              <a:t>dystroglycan</a:t>
            </a:r>
            <a:endParaRPr 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6A7438B-2971-D040-90C3-BEDBE6BB67DC}"/>
              </a:ext>
            </a:extLst>
          </p:cNvPr>
          <p:cNvSpPr txBox="1"/>
          <p:nvPr/>
        </p:nvSpPr>
        <p:spPr>
          <a:xfrm>
            <a:off x="6637650" y="4167500"/>
            <a:ext cx="16092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β</a:t>
            </a:r>
            <a:r>
              <a:rPr lang="en-US" dirty="0"/>
              <a:t>-</a:t>
            </a:r>
            <a:r>
              <a:rPr lang="en-US" dirty="0" err="1"/>
              <a:t>dystroglycan</a:t>
            </a:r>
            <a:endParaRPr lang="en-US" dirty="0"/>
          </a:p>
        </p:txBody>
      </p:sp>
      <p:sp>
        <p:nvSpPr>
          <p:cNvPr id="7" name="Left Brace 6">
            <a:extLst>
              <a:ext uri="{FF2B5EF4-FFF2-40B4-BE49-F238E27FC236}">
                <a16:creationId xmlns:a16="http://schemas.microsoft.com/office/drawing/2014/main" id="{6ED91F74-F06E-704D-91FA-FBB59D596568}"/>
              </a:ext>
            </a:extLst>
          </p:cNvPr>
          <p:cNvSpPr/>
          <p:nvPr/>
        </p:nvSpPr>
        <p:spPr>
          <a:xfrm rot="16200000">
            <a:off x="5330305" y="3917599"/>
            <a:ext cx="136933" cy="1892768"/>
          </a:xfrm>
          <a:prstGeom prst="leftBrace">
            <a:avLst/>
          </a:prstGeom>
          <a:ln w="19050">
            <a:solidFill>
              <a:schemeClr val="accent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2FD441A-F5AF-9A41-A0CB-5FBE6EC62418}"/>
              </a:ext>
            </a:extLst>
          </p:cNvPr>
          <p:cNvSpPr txBox="1"/>
          <p:nvPr/>
        </p:nvSpPr>
        <p:spPr>
          <a:xfrm>
            <a:off x="4882069" y="4998063"/>
            <a:ext cx="10756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nti-Cor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330C6F0-E1B1-CD46-BFDE-B0E1CE95A868}"/>
              </a:ext>
            </a:extLst>
          </p:cNvPr>
          <p:cNvSpPr txBox="1"/>
          <p:nvPr/>
        </p:nvSpPr>
        <p:spPr>
          <a:xfrm>
            <a:off x="838200" y="1367522"/>
            <a:ext cx="85606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Membrane was probed with anti-core dystroglycan antibody</a:t>
            </a:r>
          </a:p>
        </p:txBody>
      </p:sp>
    </p:spTree>
    <p:extLst>
      <p:ext uri="{BB962C8B-B14F-4D97-AF65-F5344CB8AC3E}">
        <p14:creationId xmlns:p14="http://schemas.microsoft.com/office/powerpoint/2010/main" val="20015702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8</TotalTime>
  <Words>60</Words>
  <Application>Microsoft Macintosh PowerPoint</Application>
  <PresentationFormat>Widescreen</PresentationFormat>
  <Paragraphs>11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iMyoblasts for ex vivo and in vivo investigations of human myogenesis and disease modeling </vt:lpstr>
      <vt:lpstr>Source data for Figure 9F</vt:lpstr>
      <vt:lpstr>Source data for Figure 9F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man, Katelyn</dc:creator>
  <cp:lastModifiedBy>Daman, Katelyn</cp:lastModifiedBy>
  <cp:revision>3</cp:revision>
  <dcterms:created xsi:type="dcterms:W3CDTF">2021-05-25T15:12:17Z</dcterms:created>
  <dcterms:modified xsi:type="dcterms:W3CDTF">2021-11-18T19:04:17Z</dcterms:modified>
</cp:coreProperties>
</file>